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  <p:sldId id="259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" userDrawn="1">
          <p15:clr>
            <a:srgbClr val="A4A3A4"/>
          </p15:clr>
        </p15:guide>
        <p15:guide id="2" pos="4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16"/>
    <p:restoredTop sz="94688"/>
  </p:normalViewPr>
  <p:slideViewPr>
    <p:cSldViewPr snapToGrid="0" showGuides="1">
      <p:cViewPr varScale="1">
        <p:scale>
          <a:sx n="147" d="100"/>
          <a:sy n="147" d="100"/>
        </p:scale>
        <p:origin x="6224" y="192"/>
      </p:cViewPr>
      <p:guideLst>
        <p:guide orient="horz" pos="432"/>
        <p:guide pos="4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079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786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415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702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141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092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864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353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500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828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525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17B1E5-778D-4343-8351-C1AF773B63B6}" type="datetimeFigureOut">
              <a:rPr lang="en-US" smtClean="0"/>
              <a:t>1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A2272-6622-DE46-AE18-D3DB80B3E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777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46741D6-1F20-A4F2-CA1D-2EFBCF7568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4505" y="906600"/>
            <a:ext cx="2854895" cy="4292611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036280E7-F996-4D28-A7DD-540A5B308853}"/>
              </a:ext>
            </a:extLst>
          </p:cNvPr>
          <p:cNvCxnSpPr>
            <a:cxnSpLocks/>
          </p:cNvCxnSpPr>
          <p:nvPr/>
        </p:nvCxnSpPr>
        <p:spPr>
          <a:xfrm>
            <a:off x="2670474" y="5215183"/>
            <a:ext cx="0" cy="48768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59E322B8-E724-FCD1-8F16-33EB7C3EFB4F}"/>
              </a:ext>
            </a:extLst>
          </p:cNvPr>
          <p:cNvSpPr txBox="1"/>
          <p:nvPr/>
        </p:nvSpPr>
        <p:spPr>
          <a:xfrm>
            <a:off x="2686561" y="5290022"/>
            <a:ext cx="3506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Excise SMA20 spot, de novo sequence tryptic peptides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88D43323-0745-9842-7BFB-AC8ECA3B0937}"/>
              </a:ext>
            </a:extLst>
          </p:cNvPr>
          <p:cNvCxnSpPr>
            <a:cxnSpLocks/>
          </p:cNvCxnSpPr>
          <p:nvPr/>
        </p:nvCxnSpPr>
        <p:spPr>
          <a:xfrm>
            <a:off x="2670474" y="5991144"/>
            <a:ext cx="0" cy="48768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EF49FF35-3F43-851B-A7AD-4E1C4DA4B72F}"/>
              </a:ext>
            </a:extLst>
          </p:cNvPr>
          <p:cNvCxnSpPr>
            <a:cxnSpLocks/>
          </p:cNvCxnSpPr>
          <p:nvPr/>
        </p:nvCxnSpPr>
        <p:spPr>
          <a:xfrm>
            <a:off x="2670474" y="7617067"/>
            <a:ext cx="0" cy="48768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1A59FDF-4B47-278D-1A83-1BE445EDFF46}"/>
              </a:ext>
            </a:extLst>
          </p:cNvPr>
          <p:cNvCxnSpPr>
            <a:cxnSpLocks/>
          </p:cNvCxnSpPr>
          <p:nvPr/>
        </p:nvCxnSpPr>
        <p:spPr>
          <a:xfrm>
            <a:off x="2670474" y="6787808"/>
            <a:ext cx="0" cy="48768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B90741FB-2E90-C3FB-1882-3AA9BCBAD9A9}"/>
              </a:ext>
            </a:extLst>
          </p:cNvPr>
          <p:cNvSpPr txBox="1"/>
          <p:nvPr/>
        </p:nvSpPr>
        <p:spPr>
          <a:xfrm>
            <a:off x="701153" y="5662010"/>
            <a:ext cx="49009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eptide </a:t>
            </a:r>
            <a:r>
              <a:rPr lang="en-US" sz="1200" dirty="0" err="1"/>
              <a:t>NSKWEEAYiNSGR</a:t>
            </a:r>
            <a:r>
              <a:rPr lang="en-US" sz="1200" dirty="0"/>
              <a:t>; no match to known proteins [Cormier et al. 2018]  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AB4ACDC-4D0E-6E15-4CCF-D46119DC25D4}"/>
              </a:ext>
            </a:extLst>
          </p:cNvPr>
          <p:cNvSpPr txBox="1"/>
          <p:nvPr/>
        </p:nvSpPr>
        <p:spPr>
          <a:xfrm>
            <a:off x="1377361" y="6513452"/>
            <a:ext cx="2599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rtial length SMA20 3’ cDNA (436 bp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A82668A-1D51-31AE-ACAA-A3BC561E3992}"/>
              </a:ext>
            </a:extLst>
          </p:cNvPr>
          <p:cNvSpPr txBox="1"/>
          <p:nvPr/>
        </p:nvSpPr>
        <p:spPr>
          <a:xfrm>
            <a:off x="1387715" y="7319150"/>
            <a:ext cx="2592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rtial length SMA20 5’ cDNA (432 bp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A5FAE3-B700-0A8A-8779-841BEEF003EE}"/>
              </a:ext>
            </a:extLst>
          </p:cNvPr>
          <p:cNvSpPr txBox="1"/>
          <p:nvPr/>
        </p:nvSpPr>
        <p:spPr>
          <a:xfrm>
            <a:off x="1202621" y="8138951"/>
            <a:ext cx="2955819" cy="27699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/>
              <a:t>Full length SMA20 composite cDNA (786 bp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4DD19D9-42AA-38B0-F6A0-0B9EFE878775}"/>
              </a:ext>
            </a:extLst>
          </p:cNvPr>
          <p:cNvSpPr txBox="1"/>
          <p:nvPr/>
        </p:nvSpPr>
        <p:spPr>
          <a:xfrm>
            <a:off x="2686561" y="5981459"/>
            <a:ext cx="33349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3’ RACE with nested, degenerate, sense strand primers; pig testis cDNA template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12EBB76-87CC-72EE-3320-F313146DDA5C}"/>
              </a:ext>
            </a:extLst>
          </p:cNvPr>
          <p:cNvSpPr txBox="1"/>
          <p:nvPr/>
        </p:nvSpPr>
        <p:spPr>
          <a:xfrm>
            <a:off x="2686561" y="6806941"/>
            <a:ext cx="33349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5’ RACE with SMA20-specific antisense primers; pig testis cDNA template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24DDBA9-D279-A51C-AD04-0BF68B02188D}"/>
              </a:ext>
            </a:extLst>
          </p:cNvPr>
          <p:cNvSpPr txBox="1"/>
          <p:nvPr/>
        </p:nvSpPr>
        <p:spPr>
          <a:xfrm>
            <a:off x="2686561" y="7601607"/>
            <a:ext cx="25372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Assemble 3’ and 5’ product sequences into contig 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9052E26F-51F3-06CC-360D-58D152D72FE8}"/>
              </a:ext>
            </a:extLst>
          </p:cNvPr>
          <p:cNvCxnSpPr>
            <a:cxnSpLocks/>
          </p:cNvCxnSpPr>
          <p:nvPr/>
        </p:nvCxnSpPr>
        <p:spPr>
          <a:xfrm>
            <a:off x="1506082" y="844617"/>
            <a:ext cx="2387600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7FB2295A-D35C-BA3D-B1BD-8B572DAD2EBD}"/>
              </a:ext>
            </a:extLst>
          </p:cNvPr>
          <p:cNvSpPr txBox="1"/>
          <p:nvPr/>
        </p:nvSpPr>
        <p:spPr>
          <a:xfrm>
            <a:off x="2596488" y="726323"/>
            <a:ext cx="176330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/>
              <a:t>p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DFA2487-C9D7-D661-7158-340371FDD9A7}"/>
              </a:ext>
            </a:extLst>
          </p:cNvPr>
          <p:cNvSpPr txBox="1"/>
          <p:nvPr/>
        </p:nvSpPr>
        <p:spPr>
          <a:xfrm>
            <a:off x="3927162" y="743659"/>
            <a:ext cx="7854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/>
              <a:t>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599E57C-0C3A-581C-940F-ED042C7CFC98}"/>
              </a:ext>
            </a:extLst>
          </p:cNvPr>
          <p:cNvSpPr txBox="1"/>
          <p:nvPr/>
        </p:nvSpPr>
        <p:spPr>
          <a:xfrm>
            <a:off x="1319131" y="743659"/>
            <a:ext cx="15709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/>
              <a:t>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0699EAF-0ACB-B4F9-99A2-8CEA65F9825A}"/>
              </a:ext>
            </a:extLst>
          </p:cNvPr>
          <p:cNvSpPr txBox="1"/>
          <p:nvPr/>
        </p:nvSpPr>
        <p:spPr>
          <a:xfrm>
            <a:off x="1005586" y="1083413"/>
            <a:ext cx="216406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15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E3BEE66-9579-BB19-7A6E-FFF88B533950}"/>
              </a:ext>
            </a:extLst>
          </p:cNvPr>
          <p:cNvSpPr txBox="1"/>
          <p:nvPr/>
        </p:nvSpPr>
        <p:spPr>
          <a:xfrm>
            <a:off x="1084134" y="1327544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7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B37A696-4298-2D8A-9FC7-AD2086FB2DAC}"/>
              </a:ext>
            </a:extLst>
          </p:cNvPr>
          <p:cNvSpPr txBox="1"/>
          <p:nvPr/>
        </p:nvSpPr>
        <p:spPr>
          <a:xfrm>
            <a:off x="1084134" y="1523279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5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FD8C9FB-D24B-8C9D-586A-CF55E714E0C3}"/>
              </a:ext>
            </a:extLst>
          </p:cNvPr>
          <p:cNvSpPr txBox="1"/>
          <p:nvPr/>
        </p:nvSpPr>
        <p:spPr>
          <a:xfrm>
            <a:off x="1084134" y="1714682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37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F9F7E93-D8F4-7387-B804-529016EC59F1}"/>
              </a:ext>
            </a:extLst>
          </p:cNvPr>
          <p:cNvSpPr txBox="1"/>
          <p:nvPr/>
        </p:nvSpPr>
        <p:spPr>
          <a:xfrm>
            <a:off x="1084134" y="2122767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2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E878941-5837-AED5-90DB-0D83A74BCA07}"/>
              </a:ext>
            </a:extLst>
          </p:cNvPr>
          <p:cNvSpPr txBox="1"/>
          <p:nvPr/>
        </p:nvSpPr>
        <p:spPr>
          <a:xfrm>
            <a:off x="1084134" y="2656528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1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BBFFF50-97A3-15AD-D001-1A2DDD9C3A87}"/>
              </a:ext>
            </a:extLst>
          </p:cNvPr>
          <p:cNvSpPr txBox="1"/>
          <p:nvPr/>
        </p:nvSpPr>
        <p:spPr>
          <a:xfrm>
            <a:off x="1084134" y="2314892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2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0792E61-DCBC-5A69-22F1-27E090868B90}"/>
              </a:ext>
            </a:extLst>
          </p:cNvPr>
          <p:cNvSpPr txBox="1"/>
          <p:nvPr/>
        </p:nvSpPr>
        <p:spPr>
          <a:xfrm>
            <a:off x="1005586" y="3003942"/>
            <a:ext cx="216406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15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F6A62A8-E5D8-A6AC-DA44-93D849DB5EAE}"/>
              </a:ext>
            </a:extLst>
          </p:cNvPr>
          <p:cNvSpPr txBox="1"/>
          <p:nvPr/>
        </p:nvSpPr>
        <p:spPr>
          <a:xfrm>
            <a:off x="1084134" y="3226405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7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A925E17-45F6-5A9B-40F6-8850A55344EF}"/>
              </a:ext>
            </a:extLst>
          </p:cNvPr>
          <p:cNvSpPr txBox="1"/>
          <p:nvPr/>
        </p:nvSpPr>
        <p:spPr>
          <a:xfrm>
            <a:off x="1084134" y="3448142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5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DD992BE-41B5-81E7-ABF7-A123E11A81AE}"/>
              </a:ext>
            </a:extLst>
          </p:cNvPr>
          <p:cNvSpPr txBox="1"/>
          <p:nvPr/>
        </p:nvSpPr>
        <p:spPr>
          <a:xfrm>
            <a:off x="1084134" y="3682882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37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F59C6BF-82C3-4A6E-1A0F-5262273CC1E3}"/>
              </a:ext>
            </a:extLst>
          </p:cNvPr>
          <p:cNvSpPr txBox="1"/>
          <p:nvPr/>
        </p:nvSpPr>
        <p:spPr>
          <a:xfrm>
            <a:off x="1084134" y="4134303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2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21DCCFE-31D2-E16D-38C6-B4F031049EF0}"/>
              </a:ext>
            </a:extLst>
          </p:cNvPr>
          <p:cNvSpPr txBox="1"/>
          <p:nvPr/>
        </p:nvSpPr>
        <p:spPr>
          <a:xfrm>
            <a:off x="1084134" y="4763404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1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1A66811-B0A1-D2EC-6D1F-FED8DB9853F3}"/>
              </a:ext>
            </a:extLst>
          </p:cNvPr>
          <p:cNvSpPr txBox="1"/>
          <p:nvPr/>
        </p:nvSpPr>
        <p:spPr>
          <a:xfrm>
            <a:off x="1084134" y="4374097"/>
            <a:ext cx="144270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100" dirty="0"/>
              <a:t>2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8612E04-0333-04A7-2DF9-CC087F4CEE71}"/>
              </a:ext>
            </a:extLst>
          </p:cNvPr>
          <p:cNvSpPr txBox="1"/>
          <p:nvPr/>
        </p:nvSpPr>
        <p:spPr>
          <a:xfrm>
            <a:off x="4219703" y="1586553"/>
            <a:ext cx="21727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igure S1. SMA20 cDNA cloning strategy 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CC84A2D-FB23-EBF0-BBF1-B7DD9EEBF494}"/>
                  </a:ext>
                </a:extLst>
              </p:cNvPr>
              <p:cNvSpPr txBox="1"/>
              <p:nvPr/>
            </p:nvSpPr>
            <p:spPr>
              <a:xfrm>
                <a:off x="891846" y="767055"/>
                <a:ext cx="368691" cy="30008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1050" dirty="0"/>
                  <a:t>M</a:t>
                </a:r>
                <a:r>
                  <a:rPr lang="en-US" sz="1050" i="1" dirty="0" err="1"/>
                  <a:t>r</a:t>
                </a:r>
                <a:endParaRPr lang="en-US" sz="1050" i="1" dirty="0"/>
              </a:p>
              <a:p>
                <a:pPr algn="ctr"/>
                <a14:m>
                  <m:oMath xmlns:m="http://schemas.openxmlformats.org/officeDocument/2006/math">
                    <m:r>
                      <a:rPr lang="en-US" sz="900" b="0" i="0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(</m:t>
                    </m:r>
                    <m:r>
                      <a:rPr lang="en-US" sz="900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×</m:t>
                    </m:r>
                  </m:oMath>
                </a14:m>
                <a:r>
                  <a:rPr lang="en-US" sz="900" dirty="0"/>
                  <a:t> 10</a:t>
                </a:r>
                <a:r>
                  <a:rPr lang="en-US" sz="900" baseline="30000" dirty="0"/>
                  <a:t>-3</a:t>
                </a:r>
                <a:r>
                  <a:rPr lang="en-US" sz="900" dirty="0"/>
                  <a:t>)</a:t>
                </a:r>
              </a:p>
            </p:txBody>
          </p:sp>
        </mc:Choice>
        <mc:Fallback xmlns=""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CC84A2D-FB23-EBF0-BBF1-B7DD9EEBF49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91846" y="767055"/>
                <a:ext cx="368691" cy="300082"/>
              </a:xfrm>
              <a:prstGeom prst="rect">
                <a:avLst/>
              </a:prstGeom>
              <a:blipFill>
                <a:blip r:embed="rId3"/>
                <a:stretch>
                  <a:fillRect l="-13333" t="-12500" r="-16667" b="-25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3357135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867B4E6-0121-D379-25E4-9E1C54D5E55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531363"/>
              </p:ext>
            </p:extLst>
          </p:nvPr>
        </p:nvGraphicFramePr>
        <p:xfrm>
          <a:off x="1092786" y="1303895"/>
          <a:ext cx="5136274" cy="1663123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5C22544A-7EE6-4342-B048-85BDC9FD1C3A}</a:tableStyleId>
              </a:tblPr>
              <a:tblGrid>
                <a:gridCol w="1828727">
                  <a:extLst>
                    <a:ext uri="{9D8B030D-6E8A-4147-A177-3AD203B41FA5}">
                      <a16:colId xmlns:a16="http://schemas.microsoft.com/office/drawing/2014/main" val="73351840"/>
                    </a:ext>
                  </a:extLst>
                </a:gridCol>
                <a:gridCol w="3307547">
                  <a:extLst>
                    <a:ext uri="{9D8B030D-6E8A-4147-A177-3AD203B41FA5}">
                      <a16:colId xmlns:a16="http://schemas.microsoft.com/office/drawing/2014/main" val="3463583221"/>
                    </a:ext>
                  </a:extLst>
                </a:gridCol>
              </a:tblGrid>
              <a:tr h="23758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sng" dirty="0">
                          <a:solidFill>
                            <a:schemeClr val="tx1"/>
                          </a:solidFill>
                          <a:effectLst/>
                        </a:rPr>
                        <a:t>Primer name</a:t>
                      </a:r>
                      <a:endParaRPr lang="en-US" sz="1100" b="0" u="sng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sng" dirty="0">
                          <a:solidFill>
                            <a:schemeClr val="tx1"/>
                          </a:solidFill>
                          <a:effectLst/>
                        </a:rPr>
                        <a:t>Nucleotide sequence (5’ to 3’)</a:t>
                      </a:r>
                      <a:endParaRPr lang="en-US" sz="1100" b="0" u="sng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3741199"/>
                  </a:ext>
                </a:extLst>
              </a:tr>
              <a:tr h="23758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M6CL7_15-45_Rev_5’RACE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AGCCAACCAGTTCGGCCTGAGTTGAGGTAGG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5462"/>
                  </a:ext>
                </a:extLst>
              </a:tr>
              <a:tr h="23758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M6CL7_104-140_Rev_5’RACE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GTGGATGAACCCATTGGCTACCGGGCCTGGCCTTCA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3594967"/>
                  </a:ext>
                </a:extLst>
              </a:tr>
              <a:tr h="23758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M6CL7_312-338_Rev_5’RACE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CGCAGGGCCCCCAAGGAGGAAGATACC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7866724"/>
                  </a:ext>
                </a:extLst>
              </a:tr>
              <a:tr h="23758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M6CL8_35-56_Rev_5’RACE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CGAATACATCCAGCCAACCAGT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9923925"/>
                  </a:ext>
                </a:extLst>
              </a:tr>
              <a:tr h="23758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M6CL8_38-57_Rev_5’RACE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GCGAATACATCCAGCCAACC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8109383"/>
                  </a:ext>
                </a:extLst>
              </a:tr>
              <a:tr h="23758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M6CL8_61-83_Rev_5’RACE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AATGAGGCCAAAACCGATAAGC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7472" marR="674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15134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F23422A-3861-2994-B533-AA9A3DC7E2F9}"/>
              </a:ext>
            </a:extLst>
          </p:cNvPr>
          <p:cNvSpPr txBox="1"/>
          <p:nvPr/>
        </p:nvSpPr>
        <p:spPr>
          <a:xfrm>
            <a:off x="1047942" y="920874"/>
            <a:ext cx="1768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able S1. 5’ RACE primers</a:t>
            </a:r>
          </a:p>
        </p:txBody>
      </p:sp>
    </p:spTree>
    <p:extLst>
      <p:ext uri="{BB962C8B-B14F-4D97-AF65-F5344CB8AC3E}">
        <p14:creationId xmlns:p14="http://schemas.microsoft.com/office/powerpoint/2010/main" val="1396321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18</TotalTime>
  <Words>172</Words>
  <Application>Microsoft Macintosh PowerPoint</Application>
  <PresentationFormat>Letter Paper (8.5x11 in)</PresentationFormat>
  <Paragraphs>4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9</cp:revision>
  <dcterms:created xsi:type="dcterms:W3CDTF">2023-12-22T20:53:51Z</dcterms:created>
  <dcterms:modified xsi:type="dcterms:W3CDTF">2024-01-04T21:33:02Z</dcterms:modified>
</cp:coreProperties>
</file>